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9" r:id="rId4"/>
    <p:sldId id="258" r:id="rId5"/>
    <p:sldId id="256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42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3985A1-2B74-4FB1-9DDF-8992958561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7F8C5A7-D7FA-4D73-992A-5BD95337EB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4F5F48-85DF-4809-BC60-4FDBA3330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EF5D606-E3AF-4DD1-8103-460FE20AA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6FCD19-7A38-4845-BF23-2F41D0C3C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2814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960B46-E77A-494C-AFD5-B04F3BE33C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0A623A-392C-479D-AC7F-DA3F2D0392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46103D-A1CD-4A4E-B43C-893F9D00D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2E22BA-11C0-4660-A337-B0F79D230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BCAB33-2527-4D9C-9AE5-7C910AA2B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5233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E141C3C-B6AE-4941-87D4-9F727634BE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99F308-03EC-4B40-B7C7-2BB83E61DF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6397A6-CC73-416C-8BA6-1EDDB3A1E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B0FC906-7A62-4BA8-A50A-62EF0A463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859F39-FF03-4AAE-A6EE-481456D39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2430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DB543E-F70F-4339-BBB9-0CFDB990C3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E240423-A1F8-4EA2-AA25-A9F07B609E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221621-2737-4FC4-ABCE-EEF1A4B35D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6536AD-0172-4772-BC89-8D5C855A1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89AB33-ADD2-4A5A-AF68-16120B4D1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611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44939E-CF3D-4453-A61A-7FDA6BDC51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0FB97C5-119A-4C8B-94FE-767521E1AF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C6223D-90C4-482F-B018-86B300084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7198EE-8694-43FF-B2C6-23BD57F7C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6D52890-9DFC-4CEA-8EE9-34F016197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9272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278D66-9264-4BBA-B2EE-70BA711D9D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A8192B6-2B6D-4006-8AD4-752071AAD5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D8EC4FB-ECD9-44A0-88C7-32864741AB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6E1FD10-A1E9-4C72-90E0-30E85EAAB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BEA6B1-99B8-41B0-BCA4-440E0CED20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2DE3B3B-519B-472D-99D9-AF0B87B32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1681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2E8EBA-7F49-4153-980B-7C13ADF4D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3575D80-5F04-4539-BBAB-5D9BBC6926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0FB0597-9A22-4EB3-8186-C3204D1D5D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6EABBD4-584C-46D4-A12F-6707341884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8E0244C-97B6-4417-BFFD-0185A966B8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B4DFA30-286A-4349-8F9D-C09179097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C1C2052-B61B-40B3-9EE0-5D3DA796B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6526750-BA7E-4613-863C-90E11BDB3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4790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FB43BA-D09A-4339-9E6E-3FAE29A947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4B88A80-0D13-4516-B6B2-649E10AEA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0350A4B-F5FF-4D31-A817-46DCE154F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E0B788C-BB81-47D6-8485-0697EC070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9337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F9E5FC6-6370-4868-89A3-E819004C5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CD3E745-0BA7-4778-A30D-79C80CF33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8AB8A8A-4AED-4C78-BED9-86ABE821B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6953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1E4DA4-549F-42E1-A79A-DB890ABBC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2F6AF71-396A-4EDF-94D6-45CEEB36E1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40D0D9B-CDFE-435D-8BF2-DDAF9A9FB8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4858149-0FDB-413C-A402-5DA39822D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CE066B0-110B-4AC3-B734-453A414FA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D3C5C2C-951E-41B4-97BB-E28238CE7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3688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CFD0E6-7AF6-41D3-B228-2F6996DD6A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99E6F53-EC3C-48AE-A699-CC57E86C06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C5E03CF-3CC6-43B6-BEDB-45666DC887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2031DBD-F30A-48BC-9E37-7C03FC96F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062B808-CE9B-4DCC-BD59-05A437C7A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12B4A0-6F4E-4548-BE1C-AB7BD7486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2183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D4FBAF3-5EE9-4B5B-A434-E236FABCE0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EAC6264-9FBA-4DD6-93B5-97CF527B1D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DCA00E-7EDF-4089-87EA-04DF55BDCC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65CF7A-7115-4D35-A846-67669FEB0ED4}" type="datetimeFigureOut">
              <a:rPr lang="zh-CN" altLang="en-US" smtClean="0"/>
              <a:t>2022-02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60754C-3679-49A3-ABF5-E2BB31666D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5A7330-6E92-4D8A-98CA-39C4AD5431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95F90A-BA3B-4B4D-A01F-D68FDBDD23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8104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744D3CA-F48A-4CA5-AC80-159910F3E9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769" y="402409"/>
            <a:ext cx="8100842" cy="574563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69E6D3A2-C6B2-4D5E-8FC8-8A8931BE4B2E}"/>
              </a:ext>
            </a:extLst>
          </p:cNvPr>
          <p:cNvSpPr txBox="1"/>
          <p:nvPr/>
        </p:nvSpPr>
        <p:spPr>
          <a:xfrm>
            <a:off x="2221606" y="6214057"/>
            <a:ext cx="8925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Figure S1: The two-dimensional distribution of t-SNE when k = 2.</a:t>
            </a:r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8460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C7F8D3BA-F54A-4436-B6E4-BF107A9F3CE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746"/>
          <a:stretch/>
        </p:blipFill>
        <p:spPr>
          <a:xfrm>
            <a:off x="1732882" y="0"/>
            <a:ext cx="8520175" cy="600799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D78B8184-EDD8-4C63-A29A-090F3BFBDEEA}"/>
              </a:ext>
            </a:extLst>
          </p:cNvPr>
          <p:cNvSpPr txBox="1"/>
          <p:nvPr/>
        </p:nvSpPr>
        <p:spPr>
          <a:xfrm>
            <a:off x="2221606" y="6214057"/>
            <a:ext cx="8925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Figure S2: </a:t>
            </a:r>
            <a:r>
              <a:rPr lang="en-US" altLang="zh-CN" sz="180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the cutoff point of riskscore obtained by “survminer” package</a:t>
            </a:r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34032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C353A5C-FA73-4EB8-8D73-0F19B63F43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9243" y="0"/>
            <a:ext cx="8553513" cy="605318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1C61E196-CAFB-4447-BD4E-7CD5B6417758}"/>
              </a:ext>
            </a:extLst>
          </p:cNvPr>
          <p:cNvSpPr txBox="1"/>
          <p:nvPr/>
        </p:nvSpPr>
        <p:spPr>
          <a:xfrm>
            <a:off x="2221606" y="6214057"/>
            <a:ext cx="8925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Figure S3: </a:t>
            </a:r>
            <a:r>
              <a:rPr lang="en-US" altLang="zh-CN" sz="1800"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Association between riskscore and primary outcome of patients.</a:t>
            </a:r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49073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1B40B61-92D5-4075-B021-DAC5C120B9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4006" y="0"/>
            <a:ext cx="8543987" cy="605318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647A3D2-041C-4730-B3F5-00C839E6D5F6}"/>
              </a:ext>
            </a:extLst>
          </p:cNvPr>
          <p:cNvSpPr txBox="1"/>
          <p:nvPr/>
        </p:nvSpPr>
        <p:spPr>
          <a:xfrm>
            <a:off x="1824006" y="6211669"/>
            <a:ext cx="89250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Figure S4: </a:t>
            </a:r>
            <a:r>
              <a:rPr lang="en-US" altLang="zh-CN" sz="1800">
                <a:latin typeface="Arial" panose="020B0604020202020204" pitchFamily="34" charset="0"/>
                <a:cs typeface="Arial" panose="020B0604020202020204" pitchFamily="34" charset="0"/>
              </a:rPr>
              <a:t>Waterfall plot displays the mutation status of genes with high mutation frequencies in high- and low-risk groups.</a:t>
            </a:r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20414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0F4FF5A-BEA8-46FC-ACB2-86FD96C4C3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0576" y="402409"/>
            <a:ext cx="9611395" cy="581164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C4FE7BB0-7C9E-4061-BA08-B96651BBB1E1}"/>
              </a:ext>
            </a:extLst>
          </p:cNvPr>
          <p:cNvSpPr txBox="1"/>
          <p:nvPr/>
        </p:nvSpPr>
        <p:spPr>
          <a:xfrm>
            <a:off x="2221606" y="6270925"/>
            <a:ext cx="8925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Figure S5: </a:t>
            </a:r>
            <a:r>
              <a:rPr lang="en-US" altLang="zh-CN" sz="180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</a:rPr>
              <a:t>the correlation of riskscore and immune cell infiltration levels</a:t>
            </a:r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2796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2</TotalTime>
  <Words>72</Words>
  <Application>Microsoft Office PowerPoint</Application>
  <PresentationFormat>宽屏</PresentationFormat>
  <Paragraphs>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沁雨</dc:creator>
  <cp:lastModifiedBy>李 沁雨</cp:lastModifiedBy>
  <cp:revision>6</cp:revision>
  <dcterms:created xsi:type="dcterms:W3CDTF">2022-01-15T03:23:42Z</dcterms:created>
  <dcterms:modified xsi:type="dcterms:W3CDTF">2022-02-07T08:25:56Z</dcterms:modified>
</cp:coreProperties>
</file>